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22"/>
  </p:notesMasterIdLst>
  <p:sldIdLst>
    <p:sldId id="283" r:id="rId5"/>
    <p:sldId id="347" r:id="rId6"/>
    <p:sldId id="342" r:id="rId7"/>
    <p:sldId id="343" r:id="rId8"/>
    <p:sldId id="348" r:id="rId9"/>
    <p:sldId id="351" r:id="rId10"/>
    <p:sldId id="352" r:id="rId11"/>
    <p:sldId id="344" r:id="rId12"/>
    <p:sldId id="345" r:id="rId13"/>
    <p:sldId id="346" r:id="rId14"/>
    <p:sldId id="338" r:id="rId15"/>
    <p:sldId id="339" r:id="rId16"/>
    <p:sldId id="340" r:id="rId17"/>
    <p:sldId id="341" r:id="rId18"/>
    <p:sldId id="350" r:id="rId19"/>
    <p:sldId id="349" r:id="rId20"/>
    <p:sldId id="325" r:id="rId21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272FB4-DC7B-481D-B64D-B0C01DA6043D}" v="302" dt="2021-03-11T15:40:25.58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215" autoAdjust="0"/>
    <p:restoredTop sz="91398"/>
  </p:normalViewPr>
  <p:slideViewPr>
    <p:cSldViewPr snapToGrid="0" snapToObjects="1">
      <p:cViewPr varScale="1">
        <p:scale>
          <a:sx n="154" d="100"/>
          <a:sy n="154" d="100"/>
        </p:scale>
        <p:origin x="216" y="368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notesMaster" Target="notesMasters/notesMaster1.xml"/><Relationship Id="rId27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56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647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indications-and-hemoglobin-thresholds-for-red-blood-cell-transfusion-in-the-adult" TargetMode="External"/><Relationship Id="rId2" Type="http://schemas.openxmlformats.org/officeDocument/2006/relationships/hyperlink" Target="https://www.hematology.org/education/patients/anemia" TargetMode="Externa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685799" y="1379933"/>
            <a:ext cx="8000999" cy="1859909"/>
          </a:xfrm>
        </p:spPr>
        <p:txBody>
          <a:bodyPr/>
          <a:lstStyle/>
          <a:p>
            <a:pPr algn="ctr"/>
            <a:r>
              <a:rPr lang="en-US" sz="3600" dirty="0"/>
              <a:t>TRANSFUSION GUIDELINES</a:t>
            </a:r>
            <a:br>
              <a:rPr lang="en-US" sz="3600" dirty="0"/>
            </a:br>
            <a:br>
              <a:rPr lang="en-US" sz="3600" dirty="0"/>
            </a:br>
            <a:r>
              <a:rPr lang="en-US" sz="2400" dirty="0"/>
              <a:t>MANAGEMENT OF ANEMI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C9D2DC1-AAC5-4540-A305-F77C4E5D4C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03538" y="4572703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2907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81B1F-7B9E-8649-ACAC-C74E1708A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VALUATING FOR HEMOLYTIC AN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7F5420-FFBD-5541-995F-673D32FA40A3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Reticulocyte count ↑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Blood smear with abnormally shaped RBC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Lactate dehydrogenase (LDH) ↑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direct bilirubin ↑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aptoglobin (binds “free” hemoglobin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Intravascular hemolysis ↓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Extravascular hemolysis ↑/ normal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DE717F-E9AC-7242-B125-27908FD498F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51900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C2368-608C-194D-8353-D9F5B9729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TRANSFUSE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5659A0-3120-9947-B2CD-0AB09D15FBD9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RBCs bind hemoglobin with oxygen, therefore delivering oxygen to tissu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nemia can potentially reduce oxygen delivery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Most people, though, can increase their cardiac output over a range of hemoglobin concentrations to increase oxygen delivery to tissu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9B6352-B1AA-874D-9CC1-6F088E7679D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992182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0A888-6FCF-BC43-A00F-6091639C7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PTIMAL TRANSFUSION METHO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5F15BC-FDAC-074B-89C5-1A9D8FACD7DC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70180"/>
            <a:ext cx="7385180" cy="3019295"/>
          </a:xfrm>
        </p:spPr>
        <p:txBody>
          <a:bodyPr>
            <a:normAutofit fontScale="92500"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tudies suggest that a more aggressive approach to correcting anemia does not necessarily improve outcomes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dirty="0"/>
              <a:t>Standard practice should be to transfuse 1 unit of blood at a tim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im is to provide enough RBCs to maximize clinical outcomes while preventing unnecessary transfusion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A </a:t>
            </a:r>
            <a:r>
              <a:rPr lang="en-US" i="1" dirty="0"/>
              <a:t>restrictive</a:t>
            </a:r>
            <a:r>
              <a:rPr lang="en-US" dirty="0"/>
              <a:t> transfusion strategy should be utilized</a:t>
            </a:r>
          </a:p>
          <a:p>
            <a:pPr marL="1062990" lvl="2" indent="-285750">
              <a:buFont typeface="Wingdings" pitchFamily="2" charset="2"/>
              <a:buChar char="Ø"/>
            </a:pPr>
            <a:r>
              <a:rPr lang="en-US" i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Restrictive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threshold of transfusing when Hb is 7-8 g/dL compared to a </a:t>
            </a:r>
            <a:r>
              <a:rPr lang="en-US" i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liberal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threshold of transfusing when Hb is 9-10 g/dL was shown NOT to be associated with higher adverse outcomes (ie, 30-day mortality, rebleeding, myocardial infarction, cerebrovascular accident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93501E-3547-104B-84AA-6F4CDE6383E9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29533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694C35-E8CE-5545-8518-7379E5BC3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RESTRICTIVE</a:t>
            </a:r>
            <a:r>
              <a:rPr lang="en-US" dirty="0"/>
              <a:t> TRANSFUSION STRATEG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35301C-3A9D-4B47-BDCB-89D042593A6F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ransfuse at a lower hemoglobin leve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ransfuse less blood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ave a lower target hemoglobin leve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endParaRPr lang="en-US" dirty="0"/>
          </a:p>
          <a:p>
            <a:r>
              <a:rPr lang="en-US" i="1" dirty="0"/>
              <a:t>*Continue to treat underlying cause of anemia as well.*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7FE71D-6984-A640-A988-BDC87E1EC20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70258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A49B6-1572-D24D-A0D3-FFA4B3185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2369" y="979475"/>
            <a:ext cx="7863281" cy="804672"/>
          </a:xfrm>
        </p:spPr>
        <p:txBody>
          <a:bodyPr/>
          <a:lstStyle/>
          <a:p>
            <a:r>
              <a:rPr lang="en-US" dirty="0"/>
              <a:t>AABB’s GUIDELINES FOR RBC TRANSFUSION (2016) </a:t>
            </a:r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AD99164E-A7F4-5A4C-B333-5DCC7916D31A}"/>
              </a:ext>
            </a:extLst>
          </p:cNvPr>
          <p:cNvGraphicFramePr>
            <a:graphicFrameLocks noGrp="1"/>
          </p:cNvGraphicFramePr>
          <p:nvPr>
            <p:ph sz="quarter" idx="14"/>
            <p:extLst>
              <p:ext uri="{D42A27DB-BD31-4B8C-83A1-F6EECF244321}">
                <p14:modId xmlns:p14="http://schemas.microsoft.com/office/powerpoint/2010/main" val="991158040"/>
              </p:ext>
            </p:extLst>
          </p:nvPr>
        </p:nvGraphicFramePr>
        <p:xfrm>
          <a:off x="550655" y="1381811"/>
          <a:ext cx="7991857" cy="27736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27152">
                  <a:extLst>
                    <a:ext uri="{9D8B030D-6E8A-4147-A177-3AD203B41FA5}">
                      <a16:colId xmlns:a16="http://schemas.microsoft.com/office/drawing/2014/main" val="1699979048"/>
                    </a:ext>
                  </a:extLst>
                </a:gridCol>
                <a:gridCol w="3293706">
                  <a:extLst>
                    <a:ext uri="{9D8B030D-6E8A-4147-A177-3AD203B41FA5}">
                      <a16:colId xmlns:a16="http://schemas.microsoft.com/office/drawing/2014/main" val="1044135555"/>
                    </a:ext>
                  </a:extLst>
                </a:gridCol>
                <a:gridCol w="1970999">
                  <a:extLst>
                    <a:ext uri="{9D8B030D-6E8A-4147-A177-3AD203B41FA5}">
                      <a16:colId xmlns:a16="http://schemas.microsoft.com/office/drawing/2014/main" val="4109191689"/>
                    </a:ext>
                  </a:extLst>
                </a:gridCol>
              </a:tblGrid>
              <a:tr h="359812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DI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HEMOGLOBIN THRESHOL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VID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3746744"/>
                  </a:ext>
                </a:extLst>
              </a:tr>
              <a:tr h="509734">
                <a:tc>
                  <a:txBody>
                    <a:bodyPr/>
                    <a:lstStyle/>
                    <a:p>
                      <a:r>
                        <a:rPr lang="en-US" sz="1400" dirty="0"/>
                        <a:t>Hemodynamically stable &amp; hospitalized (even if critically il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 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ode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5053087"/>
                  </a:ext>
                </a:extLst>
              </a:tr>
              <a:tr h="299843">
                <a:tc>
                  <a:txBody>
                    <a:bodyPr/>
                    <a:lstStyle/>
                    <a:p>
                      <a:r>
                        <a:rPr lang="en-US" sz="1400" dirty="0"/>
                        <a:t>Pre-existing coronary artery dise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 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ode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6063947"/>
                  </a:ext>
                </a:extLst>
              </a:tr>
              <a:tr h="426658">
                <a:tc>
                  <a:txBody>
                    <a:bodyPr/>
                    <a:lstStyle/>
                    <a:p>
                      <a:r>
                        <a:rPr lang="en-US" sz="1400" dirty="0"/>
                        <a:t>Surgery (orthopedic or cardia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 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ode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297673"/>
                  </a:ext>
                </a:extLst>
              </a:tr>
              <a:tr h="426658">
                <a:tc>
                  <a:txBody>
                    <a:bodyPr/>
                    <a:lstStyle/>
                    <a:p>
                      <a:r>
                        <a:rPr lang="en-US" sz="1400" dirty="0"/>
                        <a:t>Acute coronary syndromes, severe thrombocytopenia, heme/onc disorders, chronic transfusion-dependent anem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Recommendation not made for restrictive vs liberal strategy y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nsufficien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3982624"/>
                  </a:ext>
                </a:extLst>
              </a:tr>
            </a:tbl>
          </a:graphicData>
        </a:graphic>
      </p:graphicFrame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F4B74A-45A6-8D41-8151-FE5BAB46AB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B3D5636-8E9C-344B-A2C3-69CDCA44D6A9}"/>
              </a:ext>
            </a:extLst>
          </p:cNvPr>
          <p:cNvSpPr txBox="1"/>
          <p:nvPr/>
        </p:nvSpPr>
        <p:spPr>
          <a:xfrm>
            <a:off x="841248" y="4500482"/>
            <a:ext cx="7171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solidFill>
                  <a:schemeClr val="bg1"/>
                </a:solidFill>
              </a:rPr>
              <a:t>* Depending on clinical context, may transfuse RBCs above or below above thresholds. 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D7F473-AFB5-0546-93BA-0F5B82FEA438}"/>
              </a:ext>
            </a:extLst>
          </p:cNvPr>
          <p:cNvSpPr txBox="1"/>
          <p:nvPr/>
        </p:nvSpPr>
        <p:spPr>
          <a:xfrm>
            <a:off x="550319" y="4224461"/>
            <a:ext cx="4002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ABB= American Association of Blood Banks</a:t>
            </a:r>
          </a:p>
        </p:txBody>
      </p:sp>
    </p:spTree>
    <p:extLst>
      <p:ext uri="{BB962C8B-B14F-4D97-AF65-F5344CB8AC3E}">
        <p14:creationId xmlns:p14="http://schemas.microsoft.com/office/powerpoint/2010/main" val="88205649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3604D-5D35-B44A-A25B-E6D7CC788D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APPROPRIATE RESPONSE TO TRANSFUSION &amp; WHEN TO DISCHAR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EF0EA-3F05-B14A-BD24-7C66A2B10DEF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8066314" cy="2743200"/>
          </a:xfrm>
        </p:spPr>
        <p:txBody>
          <a:bodyPr>
            <a:normAutofit fontScale="85000"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1 unit of RBCs raises hemoglobin by ~1 g/dL in an average-sized adult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Post-transfusion CBC can be performed as early as 15 minutes post transfusion (in a non-bleeding patient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Discharge parameter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emodynamically stable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eavy bleeding has stopped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Underlying cause of anemia treated or stabilized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emoglobin corrects appropriately OR hemoglobin remains stable on 2 consecutive CBCs (4-6 hours apart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118B36-61C4-3C44-87AA-857EFBDBC85B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28175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9E5CF-9D69-494C-973D-676DED5AF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ICATIONS OF TRANSFUS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57C61-C78C-4E4A-A79C-B18FB2FBBDCC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88841"/>
            <a:ext cx="6904038" cy="3000634"/>
          </a:xfrm>
        </p:spPr>
        <p:txBody>
          <a:bodyPr numCol="2">
            <a:normAutofit fontScale="92500"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Fever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fectio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Ie, HIV, Hep B &amp; C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llergic &amp; immune reaction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More common following multiple transfusion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Ie, TRALI (Transfusion-Related Acute Lung Injury)</a:t>
            </a:r>
          </a:p>
          <a:p>
            <a:pPr lvl="1" indent="0">
              <a:buNone/>
            </a:pPr>
            <a:endParaRPr lang="en-US" dirty="0"/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ron overload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More common following multiple transfusion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yperkalemia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More common with massive transfusion, CKD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Volume overload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More common with congestive heart failure, elder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78D61F-5CCA-1241-8678-E29DA3B360B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206335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A6368-7F9F-4C48-9AFF-A8A774BF6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0E0E1D-84A5-BC42-85E0-91BD899DB8B2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842502" y="1577100"/>
            <a:ext cx="6904038" cy="3093940"/>
          </a:xfrm>
        </p:spPr>
        <p:txBody>
          <a:bodyPr vert="horz" lIns="0" tIns="0" rIns="0" bIns="0" rtlCol="0" anchor="t">
            <a:normAutofit fontScale="85000" lnSpcReduction="20000"/>
          </a:bodyPr>
          <a:lstStyle/>
          <a:p>
            <a:r>
              <a:rPr lang="en-US" dirty="0"/>
              <a:t>1. Hematology.org. Anemia. American Society of Hematology website. </a:t>
            </a:r>
            <a:r>
              <a:rPr lang="en-US" dirty="0">
                <a:ea typeface="+mn-lt"/>
                <a:cs typeface="+mn-lt"/>
              </a:rPr>
              <a:t>Accessed March 11, 2021. </a:t>
            </a:r>
            <a:r>
              <a:rPr lang="en-US" dirty="0"/>
              <a:t>Available at: </a:t>
            </a:r>
            <a:r>
              <a:rPr lang="en-US" dirty="0">
                <a:ea typeface="+mn-lt"/>
                <a:cs typeface="+mn-lt"/>
                <a:hlinkClick r:id="rId2"/>
              </a:rPr>
              <a:t>https://www.hematology.org/education/patients/anemia</a:t>
            </a:r>
            <a:endParaRPr lang="en-US" dirty="0">
              <a:cs typeface="Arial"/>
            </a:endParaRPr>
          </a:p>
          <a:p>
            <a:r>
              <a:rPr lang="en-US" dirty="0"/>
              <a:t>2. Carson, J, Kleinman, S. Indications and hemoglobin thresholds for red blood cell transfusion in the adult.  Uptodate.com. Updated March 1, 2021. Accessed March 11, 2021. Available at: </a:t>
            </a:r>
            <a:r>
              <a:rPr lang="en-US" dirty="0">
                <a:hlinkClick r:id="rId3"/>
              </a:rPr>
              <a:t>https://www.uptodate.com/contents/indications-and-hemoglobin-thresholds-for-red-blood-cell-transfusion-in-the-adult</a:t>
            </a:r>
            <a:r>
              <a:rPr lang="en-US" dirty="0"/>
              <a:t>.</a:t>
            </a:r>
          </a:p>
          <a:p>
            <a:r>
              <a:rPr lang="en-US" dirty="0">
                <a:cs typeface="Arial"/>
              </a:rPr>
              <a:t>3. </a:t>
            </a:r>
            <a:r>
              <a:rPr lang="en-US" dirty="0">
                <a:ea typeface="+mn-lt"/>
                <a:cs typeface="+mn-lt"/>
              </a:rPr>
              <a:t>Carson JL, Guyatt G, Heddle NM, et al. Clinical Practice Guidelines From the AABB: Red Blood Cell Transfusion Thresholds and Storage. </a:t>
            </a:r>
            <a:r>
              <a:rPr lang="en-US" i="1" dirty="0">
                <a:ea typeface="+mn-lt"/>
                <a:cs typeface="+mn-lt"/>
              </a:rPr>
              <a:t>JAMA</a:t>
            </a:r>
            <a:r>
              <a:rPr lang="en-US" dirty="0">
                <a:ea typeface="+mn-lt"/>
                <a:cs typeface="+mn-lt"/>
              </a:rPr>
              <a:t>. 2016;316(19):2025-2035.</a:t>
            </a:r>
            <a:endParaRPr lang="en-US" dirty="0">
              <a:cs typeface="Arial"/>
            </a:endParaRPr>
          </a:p>
          <a:p>
            <a:r>
              <a:rPr lang="en-US" dirty="0"/>
              <a:t>4. Schrier, S. Approach to the adult with anemia. In: Mentzer WC, ed. Uptodate;2011.  Accessed 4/6/2021: https://somepomed.org/articulos/contents/mobipreview.htm?33/12/33985</a:t>
            </a:r>
          </a:p>
          <a:p>
            <a:r>
              <a:rPr lang="en-US" dirty="0">
                <a:cs typeface="Arial"/>
              </a:rPr>
              <a:t>5. </a:t>
            </a:r>
            <a:r>
              <a:rPr lang="en-US" dirty="0">
                <a:ea typeface="+mn-lt"/>
                <a:cs typeface="+mn-lt"/>
              </a:rPr>
              <a:t>Carson JL, Grossman BJ, Kleinman S, et al. Red blood cell transfusion: a clinical practice guideline from the AABB*. </a:t>
            </a:r>
            <a:r>
              <a:rPr lang="en-US" i="1" dirty="0">
                <a:ea typeface="+mn-lt"/>
                <a:cs typeface="+mn-lt"/>
              </a:rPr>
              <a:t>Ann Intern Med</a:t>
            </a:r>
            <a:r>
              <a:rPr lang="en-US" dirty="0">
                <a:ea typeface="+mn-lt"/>
                <a:cs typeface="+mn-lt"/>
              </a:rPr>
              <a:t>. 2012;157(1):49-58. 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B64E0D-C89F-314E-B664-2FBBBCE9BF1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95444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8AA04-C89E-3C4E-B819-F537C95F2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 OF AN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6638AA-42CE-134A-B1D3-FCB28180DF4E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E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emoglobin &lt;13.5 g/d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WOME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emoglobin &lt;12 g/dL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DE7DA3-802A-D84C-9222-F47451EAF7C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1254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6C874-C3A1-A64C-874F-50529089E4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MPTOMS OF AN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3FCB7F-44F3-0D40-946F-1E93AEC933C6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847063"/>
            <a:ext cx="6904038" cy="2743200"/>
          </a:xfrm>
        </p:spPr>
        <p:txBody>
          <a:bodyPr>
            <a:normAutofit fontScale="925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Weaknes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izzines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Palpitation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hortness of breath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hest pai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eadach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”Whooshing” sensation in ear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old extremiti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763D10-56A1-7D40-81A8-B37590B52669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E5CF63-E494-C141-9C04-8D1E6E12A65C}"/>
              </a:ext>
            </a:extLst>
          </p:cNvPr>
          <p:cNvSpPr txBox="1"/>
          <p:nvPr/>
        </p:nvSpPr>
        <p:spPr>
          <a:xfrm>
            <a:off x="4907902" y="2341500"/>
            <a:ext cx="22713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solidFill>
                  <a:schemeClr val="bg1"/>
                </a:solidFill>
              </a:rPr>
              <a:t>Note: Exertional symptoms are NOT considered an indication for RBC transfusio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5492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07B37-5E29-3D40-8371-619B4B88B0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ASSIFYING ANEMIA by morpholog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24C83D-F5D3-C74E-9665-B54DE3D62F8F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707502"/>
            <a:ext cx="7907694" cy="2981973"/>
          </a:xfrm>
        </p:spPr>
        <p:txBody>
          <a:bodyPr>
            <a:normAutofit fontScale="775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ACROCYTIC ANEMIA (mean corpuscular volume [MCV]) &gt;100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i="1" dirty="0"/>
              <a:t>Causes: </a:t>
            </a:r>
            <a:r>
              <a:rPr lang="en-US" dirty="0"/>
              <a:t>reticulocytosis, abnormal nucleic acid metabolism of erythroid precursors (ie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Vit B12 or folate deficiency</a:t>
            </a:r>
            <a:r>
              <a:rPr lang="en-US" dirty="0"/>
              <a:t>) or drugs interfering with this process (ie, Hydroxyurea, Zidovudine), abnormal maturation of RBCs (ie, acute leukemia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myelodysplastic syndrome</a:t>
            </a:r>
            <a:r>
              <a:rPr lang="en-US" dirty="0"/>
              <a:t>)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lcohol abuse</a:t>
            </a:r>
            <a:r>
              <a:rPr lang="en-US" dirty="0"/>
              <a:t>, hypothyroidism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liver diseas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NORMOCYTIC ANEMIA (MCV= 80-100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i="1" dirty="0"/>
              <a:t>Causes: </a:t>
            </a:r>
            <a:r>
              <a:rPr lang="en-US" dirty="0"/>
              <a:t>systemic disorders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nemia of chronic disease</a:t>
            </a:r>
            <a:r>
              <a:rPr lang="en-US" b="1" dirty="0"/>
              <a:t> (</a:t>
            </a:r>
            <a:r>
              <a:rPr lang="en-US" dirty="0"/>
              <a:t>ie, chronic kidney disease [CKD]), acquired anemia in a hospitalized patient (ie, from excessive blood draws, following surgeries, hemodilution, critical illness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ICROCYTIC ANEMIA (MCV&lt;80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i="1" dirty="0"/>
              <a:t>Causes: </a:t>
            </a:r>
            <a:r>
              <a:rPr lang="en-US" dirty="0"/>
              <a:t>decreased iron availability (ie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nemia of chronic disease, iron deficiency</a:t>
            </a:r>
            <a:r>
              <a:rPr lang="en-US" dirty="0"/>
              <a:t>, copper deficiency), heme synthesis disorders (ie, sideroblastic anemia, lead poisoning), decreased production of globin (ie,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Thalassemia</a:t>
            </a:r>
            <a:r>
              <a:rPr lang="en-US" dirty="0"/>
              <a:t>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D88B5F-F27B-EC4F-AFD7-CF2D0A4BB43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5400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CC66C-2BBD-0343-8390-AE78FD970D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ASSIFYING ANEMIA by kinetic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F58BEB-46C0-5047-8CB6-238A52DA0D1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837733"/>
            <a:ext cx="7889033" cy="2743200"/>
          </a:xfrm>
        </p:spPr>
        <p:txBody>
          <a:bodyPr>
            <a:normAutofit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ECREASED RBC PRODUCTIO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Due to decreased effective production or RBC precursor destructio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i="1" dirty="0"/>
              <a:t>Causes: </a:t>
            </a:r>
            <a:r>
              <a:rPr lang="en-US" dirty="0"/>
              <a:t>bone marrow suppression (ie, by drugs, chemo) or infiltration, lack of Vit B12 or folate, low hormones to stimulate RBC production (ie, erythropoietin due to CKD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CREASED RBC DESTRUCTIO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i="1" dirty="0"/>
              <a:t>Causes: </a:t>
            </a:r>
            <a:r>
              <a:rPr lang="en-US" dirty="0"/>
              <a:t>hemolytic anemias (ie, sickle cell disease, hereditary spherocytosis, malaria, paroxysmal nocturnal hemoglobinuria, Coomb’s (+) autoimmune, hypersplenism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BLOOD LOS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F9FEA1-D85A-DC4F-A540-620C0A85D56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12460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D1278-1755-BF4D-B3BA-15CA3CB3E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EN IS AN ANEMIC PATIENT APPROPRIATE FOR OBSERVATION STATUS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BFBCF9-A341-9D4C-9B6C-2C8BA2F187D8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 need of transfusion based on guidelines listed for hemoglobin threshold for transfus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emodynamically stabl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ause of anemia know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D32752-9D85-D04B-AAEE-18B007F04EDD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50763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593FA5-3349-CE42-B065-4578E179E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ANEMIA</a:t>
            </a:r>
            <a:br>
              <a:rPr lang="en-US" u="sng" dirty="0"/>
            </a:br>
            <a:r>
              <a:rPr lang="en-US" u="sng" dirty="0"/>
              <a:t>EXCLUSION</a:t>
            </a:r>
            <a:r>
              <a:rPr lang="en-US" dirty="0"/>
              <a:t> CRITERIA FOR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17CD3C-1048-104B-B1A9-24FCB4422DF2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emodynamically unstable (ie, hypotensive, tachycardic, orthostatic symptoms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cute, active hemorrhag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nemia of unknown etiology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istory of severe transfusion reac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582260-FC3B-F245-98F0-FFEE4106988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3285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3F863B6A-5B0B-CD44-AE30-5C39FDDAB6AA}"/>
              </a:ext>
            </a:extLst>
          </p:cNvPr>
          <p:cNvSpPr/>
          <p:nvPr/>
        </p:nvSpPr>
        <p:spPr>
          <a:xfrm>
            <a:off x="6064898" y="946388"/>
            <a:ext cx="2845837" cy="762601"/>
          </a:xfrm>
          <a:prstGeom prst="round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ADB96AA-D6AE-FC46-A2AF-4B8E4C960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ORATORY EVALUATION </a:t>
            </a:r>
            <a:br>
              <a:rPr lang="en-US" dirty="0"/>
            </a:br>
            <a:r>
              <a:rPr lang="en-US" dirty="0"/>
              <a:t>IN ANEMIC PATI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3DD437-4BBC-2C40-9D35-63A065A87C7A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7693090" cy="2743200"/>
          </a:xfrm>
        </p:spPr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BC: hemoglobin, hematocrit, RBC count, RBC indices (ie, MCV), WBC count, platelet coun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Reticulocyte count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b="1" dirty="0"/>
              <a:t>High: </a:t>
            </a:r>
            <a:r>
              <a:rPr lang="en-US" dirty="0"/>
              <a:t>indicates hemolysis or blood loss (</a:t>
            </a:r>
            <a:r>
              <a:rPr lang="en-US" i="1" dirty="0"/>
              <a:t>note</a:t>
            </a:r>
            <a:r>
              <a:rPr lang="en-US" dirty="0"/>
              <a:t>- can cause a </a:t>
            </a:r>
            <a:r>
              <a:rPr lang="en-US" i="1" dirty="0"/>
              <a:t>low</a:t>
            </a:r>
            <a:r>
              <a:rPr lang="en-US" dirty="0"/>
              <a:t> retic count if a concurrent disorder causes bone marrow suppression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b="1" dirty="0"/>
              <a:t>Low: </a:t>
            </a:r>
            <a:r>
              <a:rPr lang="en-US" dirty="0"/>
              <a:t>indicates deficient RBC production (ie, decreased bone marrow response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Blood smear (ie, to assess for schistocytes, teardrop cells, bite cells, RBC inclusions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186DD6-3F13-9F4A-BE7E-24FB0542C2E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DF3DB3-9BA5-F348-98A5-D6A9C55FA7A9}"/>
              </a:ext>
            </a:extLst>
          </p:cNvPr>
          <p:cNvSpPr txBox="1"/>
          <p:nvPr/>
        </p:nvSpPr>
        <p:spPr>
          <a:xfrm>
            <a:off x="6055567" y="905069"/>
            <a:ext cx="286449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i="1" dirty="0">
                <a:solidFill>
                  <a:schemeClr val="bg1"/>
                </a:solidFill>
              </a:rPr>
              <a:t>Reminder: </a:t>
            </a:r>
            <a:r>
              <a:rPr lang="en-US" sz="1500" dirty="0">
                <a:solidFill>
                  <a:schemeClr val="bg1"/>
                </a:solidFill>
              </a:rPr>
              <a:t>Must send anemia workup PRIOR to transfusing blood products.</a:t>
            </a:r>
          </a:p>
        </p:txBody>
      </p:sp>
    </p:spTree>
    <p:extLst>
      <p:ext uri="{BB962C8B-B14F-4D97-AF65-F5344CB8AC3E}">
        <p14:creationId xmlns:p14="http://schemas.microsoft.com/office/powerpoint/2010/main" val="25578212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C1806-30E3-554B-AA47-E11A60354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VALUATING FOR IRON DEFICIENCY AN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03BA1C-AE86-5142-AC95-EB89D952A866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CV ↓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ron ↓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ron binding capacity ↑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ransferrin saturation ↓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Ferritin ↓ (generally &lt;100 ng/mL)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9B89B2-0689-2F49-A6F1-B64705B58BB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032864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B6F2769-7194-4217-93D3-3AF3A4742282}">
  <ds:schemaRefs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microsoft.com/sharepoint/v3/field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42216</TotalTime>
  <Words>1148</Words>
  <Application>Microsoft Macintosh PowerPoint</Application>
  <PresentationFormat>On-screen Show (16:9)</PresentationFormat>
  <Paragraphs>142</Paragraphs>
  <Slides>1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3" baseType="lpstr">
      <vt:lpstr>Arial</vt:lpstr>
      <vt:lpstr>Calibri</vt:lpstr>
      <vt:lpstr>Courier New</vt:lpstr>
      <vt:lpstr>Lucida Grande</vt:lpstr>
      <vt:lpstr>Wingdings</vt:lpstr>
      <vt:lpstr>NYULMC_160829_16x9-Dark_+Boilerplates</vt:lpstr>
      <vt:lpstr>TRANSFUSION GUIDELINES  MANAGEMENT OF ANEMIA</vt:lpstr>
      <vt:lpstr>DEFINITION OF ANEMIA</vt:lpstr>
      <vt:lpstr>SYMPTOMS OF ANEMIA</vt:lpstr>
      <vt:lpstr>CLASSIFYING ANEMIA by morphology</vt:lpstr>
      <vt:lpstr>CLASSIFYING ANEMIA by kinetics</vt:lpstr>
      <vt:lpstr>WHEN IS AN ANEMIC PATIENT APPROPRIATE FOR OBSERVATION STATUS?</vt:lpstr>
      <vt:lpstr>ANEMIA EXCLUSION CRITERIA FOR OBSERVATION</vt:lpstr>
      <vt:lpstr>LABORATORY EVALUATION  IN ANEMIC PATIENTS</vt:lpstr>
      <vt:lpstr>EVALUATING FOR IRON DEFICIENCY ANEMIA</vt:lpstr>
      <vt:lpstr>EVALUATING FOR HEMOLYTIC ANEMIA</vt:lpstr>
      <vt:lpstr>WHY TRANSFUSE?</vt:lpstr>
      <vt:lpstr>OPTIMAL TRANSFUSION METHOD</vt:lpstr>
      <vt:lpstr>RESTRICTIVE TRANSFUSION STRATEGY</vt:lpstr>
      <vt:lpstr>AABB’s GUIDELINES FOR RBC TRANSFUSION (2016) </vt:lpstr>
      <vt:lpstr>ASSESSING APPROPRIATE RESPONSE TO TRANSFUSION &amp; WHEN TO DISCHARGE</vt:lpstr>
      <vt:lpstr>COMPLICATIONS OF TRANSFUSIONS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87</cp:revision>
  <dcterms:created xsi:type="dcterms:W3CDTF">2017-06-02T12:45:43Z</dcterms:created>
  <dcterms:modified xsi:type="dcterms:W3CDTF">2021-04-12T18:45:51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